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CAC398-DC2F-49FA-A4D9-AE042C67D2E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1A7F67-34CD-4905-B5FC-754E763D3DA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DBE819-7518-41B0-90CC-0FDD0691796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D33EA3-BF40-47EA-8838-6352230F866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4FFCE5-F937-460E-9B07-B19C797C3CC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6519A1-21BA-4AE4-8A25-5A26CEB0CD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6DA138-F61B-4BAB-AED7-5F931F1EE8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AA3A26-426C-4543-A473-F637E3E33B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8690F4-8786-4E5F-A907-306429F399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45CB6B-FA6C-4AB6-9BBF-98D81F16A2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CF4424-0419-49A4-BE39-605450B6E0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4AD0AA-9878-4691-9DC9-D5F21BF53C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C74039-6B78-4BD6-9C7B-0DF356E69E9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0" t="3152" r="0" b="22817"/>
          <a:stretch/>
        </p:blipFill>
        <p:spPr>
          <a:xfrm>
            <a:off x="374760" y="1979640"/>
            <a:ext cx="5824440" cy="626256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1800360" y="3193920"/>
            <a:ext cx="336240" cy="6001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4890960" y="4067280"/>
            <a:ext cx="336600" cy="6001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510000" y="4927680"/>
            <a:ext cx="336600" cy="6001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4734000" y="5796000"/>
            <a:ext cx="336600" cy="6001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265560" y="7542360"/>
            <a:ext cx="336600" cy="5997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802520" y="2919240"/>
            <a:ext cx="33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f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888800" y="3784680"/>
            <a:ext cx="33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f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482280" y="4665600"/>
            <a:ext cx="33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f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4753800" y="5541840"/>
            <a:ext cx="33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f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290040" y="7284960"/>
            <a:ext cx="33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f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368000" y="368280"/>
            <a:ext cx="4352040" cy="86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 u="sng">
                <a:solidFill>
                  <a:srgbClr val="000000"/>
                </a:solidFill>
                <a:uFillTx/>
                <a:latin typeface="Times New Roman"/>
              </a:rPr>
              <a:t>Alignment of the nucleotide sequences of bovine cationic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 u="sng">
                <a:solidFill>
                  <a:srgbClr val="000000"/>
                </a:solidFill>
                <a:uFillTx/>
                <a:latin typeface="Times New Roman"/>
              </a:rPr>
              <a:t>trypsinogen (BC), bovine anionic trypsinogen (BA)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 u="sng">
                <a:solidFill>
                  <a:srgbClr val="000000"/>
                </a:solidFill>
                <a:uFillTx/>
                <a:latin typeface="Times New Roman"/>
              </a:rPr>
              <a:t>and human cationic trypsinogen (HC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709920" y="131904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282680" y="1557360"/>
            <a:ext cx="336600" cy="533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305720" y="1279440"/>
            <a:ext cx="33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f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204920" y="155088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ourier New"/>
              </a:rPr>
              <a:t>AGG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204920" y="169056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ourier New"/>
              </a:rPr>
              <a:t>AGG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204920" y="183024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ourier New"/>
              </a:rPr>
              <a:t>AGG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" descr=""/>
          <p:cNvPicPr/>
          <p:nvPr/>
        </p:nvPicPr>
        <p:blipFill>
          <a:blip r:embed="rId1"/>
          <a:stretch/>
        </p:blipFill>
        <p:spPr>
          <a:xfrm>
            <a:off x="361800" y="1479600"/>
            <a:ext cx="6012000" cy="4317840"/>
          </a:xfrm>
          <a:prstGeom prst="rect">
            <a:avLst/>
          </a:prstGeom>
          <a:ln w="0">
            <a:noFill/>
          </a:ln>
        </p:spPr>
      </p:pic>
      <p:sp>
        <p:nvSpPr>
          <p:cNvPr id="60" name=""/>
          <p:cNvSpPr/>
          <p:nvPr/>
        </p:nvSpPr>
        <p:spPr>
          <a:xfrm>
            <a:off x="6180120" y="1735200"/>
            <a:ext cx="212760" cy="6001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225440" y="2593800"/>
            <a:ext cx="212760" cy="6001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2703600" y="3449520"/>
            <a:ext cx="336600" cy="6001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4311720" y="4297320"/>
            <a:ext cx="336600" cy="6001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6166440" y="1335240"/>
            <a:ext cx="33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f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670840" y="3179880"/>
            <a:ext cx="33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f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4298040" y="4000680"/>
            <a:ext cx="33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f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7" name=""/>
          <p:cNvGraphicFramePr/>
          <p:nvPr/>
        </p:nvGraphicFramePr>
        <p:xfrm>
          <a:off x="2171880" y="6629400"/>
          <a:ext cx="2031840" cy="1212840"/>
        </p:xfrm>
        <a:graphic>
          <a:graphicData uri="http://schemas.openxmlformats.org/drawingml/2006/table">
            <a:tbl>
              <a:tblPr/>
              <a:tblGrid>
                <a:gridCol w="507960"/>
                <a:gridCol w="507960"/>
                <a:gridCol w="507960"/>
                <a:gridCol w="507960"/>
              </a:tblGrid>
              <a:tr h="307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7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7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7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8" name=""/>
          <p:cNvSpPr/>
          <p:nvPr/>
        </p:nvSpPr>
        <p:spPr>
          <a:xfrm>
            <a:off x="2520360" y="6310440"/>
            <a:ext cx="1294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Identity matrix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001880" y="64501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4869000" y="5148360"/>
            <a:ext cx="336240" cy="6001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4810320" y="4856040"/>
            <a:ext cx="42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f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4790880" y="514188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ourier New"/>
              </a:rPr>
              <a:t>GC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4790880" y="528156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ourier New"/>
              </a:rPr>
              <a:t>GC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4790880" y="542124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ourier New"/>
              </a:rPr>
              <a:t>GC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7-30T15:43:49Z</dcterms:created>
  <dc:creator>icsym</dc:creator>
  <dc:description/>
  <dc:language>en-US</dc:language>
  <cp:lastModifiedBy>icsym</cp:lastModifiedBy>
  <dcterms:modified xsi:type="dcterms:W3CDTF">2009-04-22T20:01:37Z</dcterms:modified>
  <cp:revision>13</cp:revision>
  <dc:subject/>
  <dc:title>Slide 1</dc:title>
</cp:coreProperties>
</file>